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79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28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C7F3A4-1273-4840-A962-C8AA10D7F0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D3C2940-CE21-40D8-A51E-D9151ECC12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CE7336-291A-4949-A385-F06E7F8394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7D0679-215A-4E22-83BE-949DCE2B6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376B26-7472-4317-9CF7-D6DC574A8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26350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0BBAEC-2B31-4679-B04C-23CC04B7AB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2AD875-B497-413A-A846-E4852DBB8F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D7F1CC-B326-40FB-86D9-A557B4F33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DE9D0E-D87F-4B10-8963-AF3738EA54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130B31-3B05-4FDB-B375-2091E0CAA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963542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236B23C-E177-4A55-90E9-847AC1C377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0A1527-CA63-429D-8440-59770A2859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5DFFFD-CF11-4D1A-918D-F3057119A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B570B2-015F-4726-BEDC-EE875F070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08E157-372B-4468-83AD-55C29352A2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47993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A0EC2-D7B8-44DD-9DF5-E0F9557B67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7B8DCB-7322-437E-BB05-D96BC6CE71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775BFA-8F3F-4A23-9364-A594823DC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7C3993-CC13-4D00-BBEA-781D6C0A6E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BCAEE6-8520-4082-A808-96E4FEC95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334340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8328DC-ABA9-4EDB-8E7D-BDCA5D72CC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0F9796-39AE-45C6-8E96-57F07872EA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E4CA41-6E5E-475C-B0C4-825818FC7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04A158-A0E2-40A8-A50C-0B39C679C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6B3344-AAFF-440B-8AFB-59614B2CC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00100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D980B-880A-4EC5-BC86-80FC77CCCE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293235-21F1-431D-9C5F-53AE1C4D5F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417437-F5F6-425A-A8D4-EC0FFB5B84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1FB954-CF08-4326-AFD3-23D8694B7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96D4B9-6001-402F-963B-581F2025C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98DF2C-6296-4EBE-89E8-DDC2865CB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76068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782F6-56D2-4764-8DC2-CDED0674FC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DCD638-64BE-4026-A7AC-839CA64B16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974812-C449-48F2-B5B9-9FF8E45824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13CD701-319B-489D-BC6E-AB1E72ACE2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B88338D-9F0F-493F-8488-55A7F4EC1E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20C905D-33A1-44AE-8E95-DCCFDB4456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975B0E-C7B3-4E2B-85C4-ECB60F7B64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EDFE12-EFB0-4930-9538-1F292318B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698413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1EE483-4F0A-4C18-8EC5-44DACE3E42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43DCA5-D930-4705-9FEA-EF5555FCBE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39E9FC7-8D27-4B50-816B-52BFD368C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F692C0-807D-403C-BA62-81BF1C08EE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36287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30E3223-8BF8-42CD-8BC2-B7E018BD0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88D172-493A-4429-B31C-560ACE5F8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51A70F-61D8-4E54-99AC-CC233215A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514342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1A949B-F718-4DA4-97F1-5C12109A05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5924DD-146C-4040-A72A-0FEF900DA2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21FF82-5DE2-4BEE-B2DD-BEDFCC9E7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612CB1-76F9-4B03-8EDD-B7AD49635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00592F-EF01-43D6-ADC8-43F538A4B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F29799-ABE3-4A5D-9EC2-CA197C60D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094446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801074-CC17-4F24-A2AD-26FB1F06C9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B5B1291-D25F-4FEC-9EAE-6DAE340469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E456F7-366F-4902-BA14-6DC4A24332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03C222-9935-4302-A28E-2F9745ADDE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C19B47-5FD7-4637-B323-8FA0E07B9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4A2C0A-3B85-4250-A7D5-BAF52BFCF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182624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DAD38EA-778A-4A70-A1DB-190F81896E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78C797-4643-4709-BED4-2A7CFE3A2C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F54568-D65C-4264-B35C-CA0B64DA6E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3F5F97-5D61-453D-86EB-B7A0A87FD4C3}" type="datetimeFigureOut">
              <a:rPr lang="en-SG" smtClean="0"/>
              <a:t>19/6/21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87DA2A-A4CA-4096-847A-DB0EACF623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274791-88EE-48E8-9724-50E012781C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601A43-ED47-42C9-B8F1-F4E0EB8C0CD1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53725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86FC7636-7856-4931-A6BD-43C9B0CA9F05}"/>
              </a:ext>
            </a:extLst>
          </p:cNvPr>
          <p:cNvSpPr txBox="1"/>
          <p:nvPr/>
        </p:nvSpPr>
        <p:spPr>
          <a:xfrm>
            <a:off x="6184781" y="370609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/>
              <a:t>6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EB0ACEA-3E02-4CBA-8600-C9169EA7D91A}"/>
              </a:ext>
            </a:extLst>
          </p:cNvPr>
          <p:cNvSpPr txBox="1"/>
          <p:nvPr/>
        </p:nvSpPr>
        <p:spPr>
          <a:xfrm>
            <a:off x="6184781" y="421191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/>
              <a:t>5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32592AC-7267-42EF-943B-57F444FB6FB6}"/>
              </a:ext>
            </a:extLst>
          </p:cNvPr>
          <p:cNvSpPr txBox="1"/>
          <p:nvPr/>
        </p:nvSpPr>
        <p:spPr>
          <a:xfrm>
            <a:off x="6184781" y="476591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/>
              <a:t>3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BD311FB-F3D5-4794-B848-5DD71FB1CE4F}"/>
              </a:ext>
            </a:extLst>
          </p:cNvPr>
          <p:cNvSpPr txBox="1"/>
          <p:nvPr/>
        </p:nvSpPr>
        <p:spPr>
          <a:xfrm>
            <a:off x="6159617" y="256104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/>
              <a:t>8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8A458C7-A403-4CD6-A804-4011FB2BA648}"/>
              </a:ext>
            </a:extLst>
          </p:cNvPr>
          <p:cNvSpPr txBox="1"/>
          <p:nvPr/>
        </p:nvSpPr>
        <p:spPr>
          <a:xfrm>
            <a:off x="6159617" y="1763708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 err="1"/>
              <a:t>kDa</a:t>
            </a:r>
            <a:endParaRPr lang="en-SG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65DAD2C-B8AE-4175-B44D-DA43685A4B7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t="13531" b="17546"/>
          <a:stretch/>
        </p:blipFill>
        <p:spPr>
          <a:xfrm>
            <a:off x="270336" y="1158713"/>
            <a:ext cx="2000250" cy="406367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B9327CA-8C24-41EA-B0E0-3CF85978BEE7}"/>
              </a:ext>
            </a:extLst>
          </p:cNvPr>
          <p:cNvSpPr txBox="1"/>
          <p:nvPr/>
        </p:nvSpPr>
        <p:spPr>
          <a:xfrm>
            <a:off x="968615" y="693420"/>
            <a:ext cx="5767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/>
              <a:t>SR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439724C-DF19-4FBF-B802-CD432AC6E497}"/>
              </a:ext>
            </a:extLst>
          </p:cNvPr>
          <p:cNvSpPr txBox="1"/>
          <p:nvPr/>
        </p:nvSpPr>
        <p:spPr>
          <a:xfrm rot="17887980">
            <a:off x="208536" y="1364075"/>
            <a:ext cx="850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contro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713CB0-20F6-41BE-932C-B287BF0988C2}"/>
              </a:ext>
            </a:extLst>
          </p:cNvPr>
          <p:cNvSpPr txBox="1"/>
          <p:nvPr/>
        </p:nvSpPr>
        <p:spPr>
          <a:xfrm rot="17887980">
            <a:off x="761913" y="1426318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+ NSP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4205200-7789-4D1C-A5A8-B0B884CA412A}"/>
              </a:ext>
            </a:extLst>
          </p:cNvPr>
          <p:cNvSpPr txBox="1"/>
          <p:nvPr/>
        </p:nvSpPr>
        <p:spPr>
          <a:xfrm rot="17887980">
            <a:off x="1271056" y="1426317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+ NSP5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C20DF48-3233-487B-A09F-7406F73BB37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</a:blip>
          <a:srcRect b="24259"/>
          <a:stretch/>
        </p:blipFill>
        <p:spPr>
          <a:xfrm>
            <a:off x="2570699" y="1456507"/>
            <a:ext cx="2057400" cy="3765877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DA8C5167-1F7B-435E-821D-66B9C77C8E6A}"/>
              </a:ext>
            </a:extLst>
          </p:cNvPr>
          <p:cNvSpPr txBox="1"/>
          <p:nvPr/>
        </p:nvSpPr>
        <p:spPr>
          <a:xfrm>
            <a:off x="3179094" y="990981"/>
            <a:ext cx="7668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dirty="0"/>
              <a:t>PAIC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67CE4AC-1A9D-4D7C-8A87-2686A51F0F5A}"/>
              </a:ext>
            </a:extLst>
          </p:cNvPr>
          <p:cNvSpPr txBox="1"/>
          <p:nvPr/>
        </p:nvSpPr>
        <p:spPr>
          <a:xfrm rot="17887980">
            <a:off x="2618655" y="1912887"/>
            <a:ext cx="850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contro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84D00BE-BF3B-477A-8A38-7535AC20A255}"/>
              </a:ext>
            </a:extLst>
          </p:cNvPr>
          <p:cNvSpPr txBox="1"/>
          <p:nvPr/>
        </p:nvSpPr>
        <p:spPr>
          <a:xfrm rot="17887980">
            <a:off x="3172032" y="1975130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+ NSP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D045858-6A2D-4B90-908D-2C18D09A0C6F}"/>
              </a:ext>
            </a:extLst>
          </p:cNvPr>
          <p:cNvSpPr txBox="1"/>
          <p:nvPr/>
        </p:nvSpPr>
        <p:spPr>
          <a:xfrm rot="17887980">
            <a:off x="3681175" y="1975129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+ NSP5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072074A4-ED90-4DF7-9178-80421814C47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</a:blip>
          <a:srcRect t="2898" r="2707" b="16380"/>
          <a:stretch/>
        </p:blipFill>
        <p:spPr>
          <a:xfrm>
            <a:off x="5034373" y="497150"/>
            <a:ext cx="3935250" cy="4788699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D7F812E7-01FC-477E-837A-D2305DD39B93}"/>
              </a:ext>
            </a:extLst>
          </p:cNvPr>
          <p:cNvSpPr txBox="1"/>
          <p:nvPr/>
        </p:nvSpPr>
        <p:spPr>
          <a:xfrm>
            <a:off x="5858733" y="-38570"/>
            <a:ext cx="647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dirty="0"/>
              <a:t>PN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CFB38FB-D42F-4E38-AA0C-73E2B44BF64D}"/>
              </a:ext>
            </a:extLst>
          </p:cNvPr>
          <p:cNvSpPr txBox="1"/>
          <p:nvPr/>
        </p:nvSpPr>
        <p:spPr>
          <a:xfrm rot="17887980">
            <a:off x="5298294" y="617865"/>
            <a:ext cx="850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control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60810D4-8138-468B-B2B9-E236ADB800E0}"/>
              </a:ext>
            </a:extLst>
          </p:cNvPr>
          <p:cNvSpPr txBox="1"/>
          <p:nvPr/>
        </p:nvSpPr>
        <p:spPr>
          <a:xfrm rot="17887980">
            <a:off x="5851671" y="680108"/>
            <a:ext cx="843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+ NSP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2163072-6C4F-49AD-9DB0-44ADADB5ABE2}"/>
              </a:ext>
            </a:extLst>
          </p:cNvPr>
          <p:cNvSpPr txBox="1"/>
          <p:nvPr/>
        </p:nvSpPr>
        <p:spPr>
          <a:xfrm rot="17887980">
            <a:off x="6360814" y="680107"/>
            <a:ext cx="843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+ NSP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5297C4C-E46E-430F-9194-F561E827DDB6}"/>
              </a:ext>
            </a:extLst>
          </p:cNvPr>
          <p:cNvSpPr txBox="1"/>
          <p:nvPr/>
        </p:nvSpPr>
        <p:spPr>
          <a:xfrm rot="17887980">
            <a:off x="6846876" y="2546872"/>
            <a:ext cx="850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control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F32827B-F9D9-4218-9E39-9D8AD8C525B5}"/>
              </a:ext>
            </a:extLst>
          </p:cNvPr>
          <p:cNvSpPr txBox="1"/>
          <p:nvPr/>
        </p:nvSpPr>
        <p:spPr>
          <a:xfrm rot="17887980">
            <a:off x="7400253" y="2609115"/>
            <a:ext cx="843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+ NSP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6E053BD-2465-4F25-91BB-942296951EC5}"/>
              </a:ext>
            </a:extLst>
          </p:cNvPr>
          <p:cNvSpPr txBox="1"/>
          <p:nvPr/>
        </p:nvSpPr>
        <p:spPr>
          <a:xfrm rot="17887980">
            <a:off x="7909396" y="2609114"/>
            <a:ext cx="843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+ NSP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8A0E51D-C446-4F0A-AA63-F92F681BAA55}"/>
              </a:ext>
            </a:extLst>
          </p:cNvPr>
          <p:cNvSpPr txBox="1"/>
          <p:nvPr/>
        </p:nvSpPr>
        <p:spPr>
          <a:xfrm>
            <a:off x="7582269" y="1890437"/>
            <a:ext cx="7171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2000" dirty="0"/>
              <a:t>RPA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B4E6F70-5D30-40B4-850A-CF61F6CBD35C}"/>
              </a:ext>
            </a:extLst>
          </p:cNvPr>
          <p:cNvSpPr txBox="1"/>
          <p:nvPr/>
        </p:nvSpPr>
        <p:spPr>
          <a:xfrm>
            <a:off x="5066336" y="269191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6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C44BFA7-00B8-448A-AD17-16F34A76647A}"/>
              </a:ext>
            </a:extLst>
          </p:cNvPr>
          <p:cNvSpPr txBox="1"/>
          <p:nvPr/>
        </p:nvSpPr>
        <p:spPr>
          <a:xfrm>
            <a:off x="5066336" y="332585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18711ED-006A-4FCD-95DA-6BD6BDBB9D21}"/>
              </a:ext>
            </a:extLst>
          </p:cNvPr>
          <p:cNvSpPr txBox="1"/>
          <p:nvPr/>
        </p:nvSpPr>
        <p:spPr>
          <a:xfrm>
            <a:off x="5066336" y="446227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3990152-1EA2-4068-9EBF-ED0941A0F014}"/>
              </a:ext>
            </a:extLst>
          </p:cNvPr>
          <p:cNvSpPr txBox="1"/>
          <p:nvPr/>
        </p:nvSpPr>
        <p:spPr>
          <a:xfrm>
            <a:off x="5041740" y="200560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97B3765-4C1A-4E63-8F9E-01BF44C14693}"/>
              </a:ext>
            </a:extLst>
          </p:cNvPr>
          <p:cNvSpPr txBox="1"/>
          <p:nvPr/>
        </p:nvSpPr>
        <p:spPr>
          <a:xfrm>
            <a:off x="4993333" y="278331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SG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AC86168-FF93-42C5-982B-ADB56A29881F}"/>
              </a:ext>
            </a:extLst>
          </p:cNvPr>
          <p:cNvSpPr txBox="1"/>
          <p:nvPr/>
        </p:nvSpPr>
        <p:spPr>
          <a:xfrm>
            <a:off x="4993333" y="1399683"/>
            <a:ext cx="428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86E969B-0316-49A2-B141-E6E78DFF7C26}"/>
              </a:ext>
            </a:extLst>
          </p:cNvPr>
          <p:cNvSpPr txBox="1"/>
          <p:nvPr/>
        </p:nvSpPr>
        <p:spPr>
          <a:xfrm>
            <a:off x="4974928" y="82391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18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A7AC69B-19E8-4D34-96B7-7A3CC5F82C02}"/>
              </a:ext>
            </a:extLst>
          </p:cNvPr>
          <p:cNvSpPr txBox="1"/>
          <p:nvPr/>
        </p:nvSpPr>
        <p:spPr>
          <a:xfrm>
            <a:off x="1925167" y="268332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6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A798AE8-BF59-4C2B-88F5-B1EA97E138CF}"/>
              </a:ext>
            </a:extLst>
          </p:cNvPr>
          <p:cNvSpPr txBox="1"/>
          <p:nvPr/>
        </p:nvSpPr>
        <p:spPr>
          <a:xfrm>
            <a:off x="1925167" y="331726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2319E9D-8C53-476D-BD85-568576B97EA4}"/>
              </a:ext>
            </a:extLst>
          </p:cNvPr>
          <p:cNvSpPr txBox="1"/>
          <p:nvPr/>
        </p:nvSpPr>
        <p:spPr>
          <a:xfrm>
            <a:off x="1925167" y="445368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FA03DBE-9EA8-4BD5-90E5-99A5DFEBB2A1}"/>
              </a:ext>
            </a:extLst>
          </p:cNvPr>
          <p:cNvSpPr txBox="1"/>
          <p:nvPr/>
        </p:nvSpPr>
        <p:spPr>
          <a:xfrm>
            <a:off x="1900571" y="199701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02B8D9D-60F6-4E31-82C1-386F0CADF09D}"/>
              </a:ext>
            </a:extLst>
          </p:cNvPr>
          <p:cNvSpPr txBox="1"/>
          <p:nvPr/>
        </p:nvSpPr>
        <p:spPr>
          <a:xfrm>
            <a:off x="1852164" y="269739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SG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ED72D3A-1212-4D4C-BCF8-ACE830DBB7FC}"/>
              </a:ext>
            </a:extLst>
          </p:cNvPr>
          <p:cNvSpPr txBox="1"/>
          <p:nvPr/>
        </p:nvSpPr>
        <p:spPr>
          <a:xfrm>
            <a:off x="1852164" y="1391091"/>
            <a:ext cx="428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4EB1AF5-E5A7-43CC-9BC1-C14FCE0DE70F}"/>
              </a:ext>
            </a:extLst>
          </p:cNvPr>
          <p:cNvSpPr txBox="1"/>
          <p:nvPr/>
        </p:nvSpPr>
        <p:spPr>
          <a:xfrm>
            <a:off x="1833759" y="81532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185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6025FEC6-D9FA-44F5-8FDB-40864CD13CCF}"/>
              </a:ext>
            </a:extLst>
          </p:cNvPr>
          <p:cNvSpPr txBox="1"/>
          <p:nvPr/>
        </p:nvSpPr>
        <p:spPr>
          <a:xfrm>
            <a:off x="4288906" y="272606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6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8F7146E-B6DF-40F9-B11B-DB6A7BFE2D35}"/>
              </a:ext>
            </a:extLst>
          </p:cNvPr>
          <p:cNvSpPr txBox="1"/>
          <p:nvPr/>
        </p:nvSpPr>
        <p:spPr>
          <a:xfrm>
            <a:off x="4288906" y="33600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2F2600D5-CA80-4EF0-B4D2-2E8FCF27F8FD}"/>
              </a:ext>
            </a:extLst>
          </p:cNvPr>
          <p:cNvSpPr txBox="1"/>
          <p:nvPr/>
        </p:nvSpPr>
        <p:spPr>
          <a:xfrm>
            <a:off x="4288906" y="449643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3CE2B39-F46B-496E-B66D-1684CE74C7B3}"/>
              </a:ext>
            </a:extLst>
          </p:cNvPr>
          <p:cNvSpPr txBox="1"/>
          <p:nvPr/>
        </p:nvSpPr>
        <p:spPr>
          <a:xfrm>
            <a:off x="4264310" y="20397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3CF8BE0-2909-4822-84CE-D25457FCDD1A}"/>
              </a:ext>
            </a:extLst>
          </p:cNvPr>
          <p:cNvSpPr txBox="1"/>
          <p:nvPr/>
        </p:nvSpPr>
        <p:spPr>
          <a:xfrm>
            <a:off x="4215903" y="312484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SG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DB8A924F-20C8-4AB9-9060-B06B3A9F7748}"/>
              </a:ext>
            </a:extLst>
          </p:cNvPr>
          <p:cNvSpPr txBox="1"/>
          <p:nvPr/>
        </p:nvSpPr>
        <p:spPr>
          <a:xfrm>
            <a:off x="4215903" y="1433836"/>
            <a:ext cx="428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36C78977-24E5-49A4-BA50-4A6CE4E6DC85}"/>
              </a:ext>
            </a:extLst>
          </p:cNvPr>
          <p:cNvSpPr txBox="1"/>
          <p:nvPr/>
        </p:nvSpPr>
        <p:spPr>
          <a:xfrm>
            <a:off x="4197498" y="85806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185</a:t>
            </a:r>
          </a:p>
        </p:txBody>
      </p:sp>
    </p:spTree>
    <p:extLst>
      <p:ext uri="{BB962C8B-B14F-4D97-AF65-F5344CB8AC3E}">
        <p14:creationId xmlns:p14="http://schemas.microsoft.com/office/powerpoint/2010/main" val="3383297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FB65F6F-AD0B-4B53-9FC5-F7ED6B4D751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rcRect t="7863" b="16332"/>
          <a:stretch/>
        </p:blipFill>
        <p:spPr>
          <a:xfrm>
            <a:off x="1508454" y="1464163"/>
            <a:ext cx="4587546" cy="403906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0414B60-2538-4B1B-B6E6-A5DF707A0C55}"/>
              </a:ext>
            </a:extLst>
          </p:cNvPr>
          <p:cNvSpPr txBox="1"/>
          <p:nvPr/>
        </p:nvSpPr>
        <p:spPr>
          <a:xfrm>
            <a:off x="1553919" y="1094830"/>
            <a:ext cx="46249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dirty="0">
                <a:latin typeface="Arial" panose="020B0604020202020204" pitchFamily="34" charset="0"/>
                <a:cs typeface="Arial" panose="020B0604020202020204" pitchFamily="34" charset="0"/>
              </a:rPr>
              <a:t>SRC   </a:t>
            </a:r>
            <a:r>
              <a:rPr lang="en-SG" sz="1600" dirty="0">
                <a:latin typeface="Arial" panose="020B0604020202020204" pitchFamily="34" charset="0"/>
                <a:cs typeface="Arial" panose="020B0604020202020204" pitchFamily="34" charset="0"/>
              </a:rPr>
              <a:t>60    30     15    7.5   3.75 1.87  0.94   </a:t>
            </a:r>
            <a:r>
              <a:rPr lang="en-SG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SG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F7147E8-FC6A-4807-BB04-F0D7F947BDA0}"/>
              </a:ext>
            </a:extLst>
          </p:cNvPr>
          <p:cNvSpPr txBox="1"/>
          <p:nvPr/>
        </p:nvSpPr>
        <p:spPr>
          <a:xfrm>
            <a:off x="3053142" y="661271"/>
            <a:ext cx="64540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SG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SG" dirty="0" err="1">
                <a:latin typeface="Arial" panose="020B0604020202020204" pitchFamily="34" charset="0"/>
                <a:cs typeface="Arial" panose="020B0604020202020204" pitchFamily="34" charset="0"/>
              </a:rPr>
              <a:t>PLpro</a:t>
            </a:r>
            <a:r>
              <a:rPr lang="en-SG" dirty="0">
                <a:latin typeface="Arial" panose="020B0604020202020204" pitchFamily="34" charset="0"/>
                <a:cs typeface="Arial" panose="020B0604020202020204" pitchFamily="34" charset="0"/>
              </a:rPr>
              <a:t> (Nsp3)</a:t>
            </a:r>
            <a:endParaRPr lang="en-SG" dirty="0"/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962D142-BC38-4884-8418-6B718708D2B1}"/>
              </a:ext>
            </a:extLst>
          </p:cNvPr>
          <p:cNvCxnSpPr/>
          <p:nvPr/>
        </p:nvCxnSpPr>
        <p:spPr>
          <a:xfrm>
            <a:off x="2311243" y="1094830"/>
            <a:ext cx="328174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86FC7636-7856-4931-A6BD-43C9B0CA9F05}"/>
              </a:ext>
            </a:extLst>
          </p:cNvPr>
          <p:cNvSpPr txBox="1"/>
          <p:nvPr/>
        </p:nvSpPr>
        <p:spPr>
          <a:xfrm>
            <a:off x="6051610" y="371497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400" dirty="0">
                <a:latin typeface="Arial" panose="020B0604020202020204" pitchFamily="34" charset="0"/>
                <a:cs typeface="Arial" panose="020B0604020202020204" pitchFamily="34" charset="0"/>
              </a:rPr>
              <a:t>6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EB0ACEA-3E02-4CBA-8600-C9169EA7D91A}"/>
              </a:ext>
            </a:extLst>
          </p:cNvPr>
          <p:cNvSpPr txBox="1"/>
          <p:nvPr/>
        </p:nvSpPr>
        <p:spPr>
          <a:xfrm>
            <a:off x="6051610" y="422079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32592AC-7267-42EF-943B-57F444FB6FB6}"/>
              </a:ext>
            </a:extLst>
          </p:cNvPr>
          <p:cNvSpPr txBox="1"/>
          <p:nvPr/>
        </p:nvSpPr>
        <p:spPr>
          <a:xfrm>
            <a:off x="6051610" y="477479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4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BD311FB-F3D5-4794-B848-5DD71FB1CE4F}"/>
              </a:ext>
            </a:extLst>
          </p:cNvPr>
          <p:cNvSpPr txBox="1"/>
          <p:nvPr/>
        </p:nvSpPr>
        <p:spPr>
          <a:xfrm>
            <a:off x="6026446" y="256991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4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8A458C7-A403-4CD6-A804-4011FB2BA648}"/>
              </a:ext>
            </a:extLst>
          </p:cNvPr>
          <p:cNvSpPr txBox="1"/>
          <p:nvPr/>
        </p:nvSpPr>
        <p:spPr>
          <a:xfrm>
            <a:off x="6026446" y="1772586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SG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B75BB62-4B58-444E-81B8-310F245F83F6}"/>
              </a:ext>
            </a:extLst>
          </p:cNvPr>
          <p:cNvSpPr txBox="1"/>
          <p:nvPr/>
        </p:nvSpPr>
        <p:spPr>
          <a:xfrm>
            <a:off x="7213461" y="1572151"/>
            <a:ext cx="4587546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DS-page analysis of the cleavage of human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</a:rPr>
              <a:t>SRC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rotein, with a N-terminal GFP tag. The protein was expressed alone or in the presence of increasing concentrations of the SARS-CoV-2 protease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Lpro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endParaRPr lang="en-SG" dirty="0"/>
          </a:p>
        </p:txBody>
      </p:sp>
    </p:spTree>
    <p:extLst>
      <p:ext uri="{BB962C8B-B14F-4D97-AF65-F5344CB8AC3E}">
        <p14:creationId xmlns:p14="http://schemas.microsoft.com/office/powerpoint/2010/main" val="370299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103</Words>
  <Application>Microsoft Macintosh PowerPoint</Application>
  <PresentationFormat>Widescreen</PresentationFormat>
  <Paragraphs>5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Sierecki</dc:creator>
  <cp:lastModifiedBy>Emmott, Ed</cp:lastModifiedBy>
  <cp:revision>6</cp:revision>
  <dcterms:created xsi:type="dcterms:W3CDTF">2020-11-03T07:17:50Z</dcterms:created>
  <dcterms:modified xsi:type="dcterms:W3CDTF">2021-06-19T13:03:20Z</dcterms:modified>
</cp:coreProperties>
</file>